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AF6FD299-9E71-40B7-B8BB-B2C5A00F94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83F84C4A-1335-495D-874F-AAF8FD155C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91AA5E78-C402-45AA-A17C-69EEAD9AF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CA46765F-EBA6-43DF-B3E6-1255ABA7D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290FE7AA-FCE6-459B-BF44-7956BD267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218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E1D92F8-D5EE-4449-BA8C-76BC44C3F6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8423FD75-8941-430A-BD21-EC55CEB4E8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1BCFB42D-363B-4777-A168-203CCB03A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D66C23FE-D1CA-48E3-85DE-BECB85D08F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7ABF955E-F1F1-4544-835B-DA079272F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0328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55AEE382-F5FC-4566-91A2-5C98CE2B36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39397FC7-B99B-4712-94DE-3F549510B9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15375CFE-C619-4377-8498-7A3E1F5AE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9A88F5E9-BEF8-4EE1-B6E4-8D83B78AC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58F731F-FC80-4338-BF63-B73395A98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8908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8988CBEE-69FD-4B70-BBDC-EE09792C4A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41463665-B30B-4CA1-8670-0A2D18F600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5D38A4E8-DDBD-4B9A-87C5-7FD16EB10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8B3F9E0A-1575-4A3A-8162-E3E5EB518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B9B028C-9A74-453C-9F27-0F7EB039B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7512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C4E4A482-EE5C-4802-B951-3BCBCACDFF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A8EA0987-90DF-4EAB-B0F5-1F0079864C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AAD3D692-6E7C-437E-9FD3-C25D844D3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FDF4EE59-5061-49C8-BB3F-BC7BF1ACA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701092E6-F760-4AD8-842A-006931D2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2638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EF8810E8-B971-46EA-9447-C6E6CE3F2F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DBFFFDC1-9872-4D60-86B9-0AF6EA0C7A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90E5F55C-B472-4F6E-9388-416B15D156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7AA71717-0DFC-434B-98B6-162D50698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390774B6-74FE-411B-999A-4ED28A23E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0F9B7969-F8FB-4AD7-B931-0E67140BF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7256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3A3B4088-5BF1-4F33-B465-7DC0D9CA6A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D289E190-A25D-4774-A868-2B87D1F37E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99757334-8EDD-4309-AC6E-33501F8E3C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5694500D-E1E8-422F-B196-03E216B8A4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BBC97142-B0FE-49CB-9D09-750855CA3C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401884D3-F179-48A8-B550-2E5FA40BD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863CE37E-08AB-4376-A6E3-CF4B0CB80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091C8317-DDC2-4F3E-8198-9B96A4444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1595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520F350-1A65-4DAA-8A94-6928DA4C5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3D59B297-2987-4099-B411-702B95092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88AA775A-00E3-4753-A3CE-D8817DC94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8DEBBF32-A46A-4219-BF5A-0A31746FB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8301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A95A39D7-1217-45E0-B746-AEA2F732A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938E2DC0-506C-4A79-B30C-0FA6B498F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242DE1AF-CE1C-46E5-A67D-2C3A01B7A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4542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4501CF6-967B-4523-8848-AA311B1C7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D41360BA-4D62-4879-9E25-A0E5D462A0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AA5144A0-C3B6-43BD-A36C-29F53F1EC0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ACE8C436-0852-46CD-A6B2-8F88A3A7C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BC14C0C5-0420-4342-857B-121FF8F53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E8F68339-5DD3-4C55-A7DA-ED0BB41EB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0631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43D7016-1693-410F-9E7F-807D5B32E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94367B67-A52F-4EFB-A28A-9306223B62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14A0D687-9D73-489F-8DA6-AABB8559D9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FF97CF1C-377F-4A9F-96E5-635FA6F13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24E4C0CF-727F-4CE0-B292-33ACF2F65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B54B1076-07DF-4280-819B-114DEA864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3967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73B112AF-854B-4B08-9DDB-137259660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05D99B36-AE99-40BD-9A85-459C29F78B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A886B14A-A749-4E82-8B4E-9E851557D9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D04E6-AA89-4D79-A686-B91B2D21DA9F}" type="datetimeFigureOut">
              <a:rPr lang="de-DE" smtClean="0"/>
              <a:t>01.02.2018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360A5710-7BD1-47B1-A22B-8FD257AA60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1827FF49-6784-453B-B04D-EB7F6F1128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A0360-6CF3-4D54-A550-451F583F07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2236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xmlns="" id="{85F3416B-FA4E-4E92-B064-7332D9ACB8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9638" y="633133"/>
            <a:ext cx="5060488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IE" altLang="de-DE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 </a:t>
            </a:r>
            <a:r>
              <a:rPr kumimoji="0" lang="en-US" altLang="de-DE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	Examples of the IgG-enrichment process.</a:t>
            </a:r>
            <a:r>
              <a:rPr kumimoji="0" lang="en-US" altLang="de-DE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xmlns="" id="{7F1532B1-FFEE-4AC0-B5E8-DDF6882C1E4B}"/>
              </a:ext>
            </a:extLst>
          </p:cNvPr>
          <p:cNvSpPr/>
          <p:nvPr/>
        </p:nvSpPr>
        <p:spPr>
          <a:xfrm>
            <a:off x="1154230" y="5704568"/>
            <a:ext cx="767587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de-DE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a1-AAB enrichment via aptamer-110-K3 column-technology. Here an aptamer was used which was specific for the 2</a:t>
            </a:r>
            <a:r>
              <a:rPr lang="en-US" altLang="de-DE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d</a:t>
            </a:r>
            <a:r>
              <a:rPr lang="en-US" altLang="de-DE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tracellular loop of the beta-AAB as published before (Wallukat </a:t>
            </a:r>
            <a:r>
              <a:rPr lang="en-US" altLang="de-DE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t al.</a:t>
            </a:r>
            <a:r>
              <a:rPr lang="en-US" altLang="de-DE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2012). Sample number corresponds to a sample from a single patient.</a:t>
            </a:r>
            <a:endParaRPr lang="de-DE" altLang="de-DE" sz="1200" dirty="0"/>
          </a:p>
        </p:txBody>
      </p:sp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xmlns="" id="{311F0566-8F2F-4E2A-8D54-724C36E972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5548305"/>
              </p:ext>
            </p:extLst>
          </p:nvPr>
        </p:nvGraphicFramePr>
        <p:xfrm>
          <a:off x="1201003" y="1002465"/>
          <a:ext cx="7629098" cy="466115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16747">
                  <a:extLst>
                    <a:ext uri="{9D8B030D-6E8A-4147-A177-3AD203B41FA5}">
                      <a16:colId xmlns:a16="http://schemas.microsoft.com/office/drawing/2014/main" xmlns="" val="2060314635"/>
                    </a:ext>
                  </a:extLst>
                </a:gridCol>
                <a:gridCol w="1816747">
                  <a:extLst>
                    <a:ext uri="{9D8B030D-6E8A-4147-A177-3AD203B41FA5}">
                      <a16:colId xmlns:a16="http://schemas.microsoft.com/office/drawing/2014/main" xmlns="" val="4155939933"/>
                    </a:ext>
                  </a:extLst>
                </a:gridCol>
                <a:gridCol w="1030624">
                  <a:extLst>
                    <a:ext uri="{9D8B030D-6E8A-4147-A177-3AD203B41FA5}">
                      <a16:colId xmlns:a16="http://schemas.microsoft.com/office/drawing/2014/main" xmlns="" val="2275576270"/>
                    </a:ext>
                  </a:extLst>
                </a:gridCol>
                <a:gridCol w="981105">
                  <a:extLst>
                    <a:ext uri="{9D8B030D-6E8A-4147-A177-3AD203B41FA5}">
                      <a16:colId xmlns:a16="http://schemas.microsoft.com/office/drawing/2014/main" xmlns="" val="576594084"/>
                    </a:ext>
                  </a:extLst>
                </a:gridCol>
                <a:gridCol w="1049968">
                  <a:extLst>
                    <a:ext uri="{9D8B030D-6E8A-4147-A177-3AD203B41FA5}">
                      <a16:colId xmlns:a16="http://schemas.microsoft.com/office/drawing/2014/main" xmlns="" val="3050538142"/>
                    </a:ext>
                  </a:extLst>
                </a:gridCol>
                <a:gridCol w="933907">
                  <a:extLst>
                    <a:ext uri="{9D8B030D-6E8A-4147-A177-3AD203B41FA5}">
                      <a16:colId xmlns:a16="http://schemas.microsoft.com/office/drawing/2014/main" xmlns="" val="571867180"/>
                    </a:ext>
                  </a:extLst>
                </a:gridCol>
              </a:tblGrid>
              <a:tr h="97003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Sample </a:t>
                      </a:r>
                      <a:r>
                        <a:rPr lang="de-DE" sz="1400" dirty="0" err="1">
                          <a:effectLst/>
                        </a:rPr>
                        <a:t>no</a:t>
                      </a:r>
                      <a:r>
                        <a:rPr lang="de-DE" sz="1400" dirty="0">
                          <a:effectLst/>
                        </a:rPr>
                        <a:t>.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IgG applied onto aptamer-column</a:t>
                      </a:r>
                      <a:endParaRPr lang="de-DE" sz="1400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[µg] total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IgG eluted [µg] total yield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Yield IgG [%] of applied IgG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Mean yield IgG [%]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.D. of yield IgG [%]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xmlns="" val="3398632049"/>
                  </a:ext>
                </a:extLst>
              </a:tr>
              <a:tr h="283932">
                <a:tc rowSpan="9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5000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305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61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rowSpan="9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0.76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rowSpan="9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0.3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xmlns="" val="249929178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2086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85.5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41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26412805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7675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26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71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28902463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834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11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61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602765235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785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83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1.03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348608101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799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71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0.95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712286059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8648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58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31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158787086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610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77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1.10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207147196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680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86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1.11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14316386"/>
                  </a:ext>
                </a:extLst>
              </a:tr>
              <a:tr h="28393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2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467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302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6.47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6.47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 err="1">
                          <a:effectLst/>
                        </a:rPr>
                        <a:t>n.d</a:t>
                      </a:r>
                      <a:r>
                        <a:rPr lang="de-DE" sz="1400" dirty="0">
                          <a:effectLst/>
                        </a:rPr>
                        <a:t>.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extLst>
                  <a:ext uri="{0D108BD9-81ED-4DB2-BD59-A6C34878D82A}">
                    <a16:rowId xmlns:a16="http://schemas.microsoft.com/office/drawing/2014/main" xmlns="" val="1209401783"/>
                  </a:ext>
                </a:extLst>
              </a:tr>
              <a:tr h="283932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3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29680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87.5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0.29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0.36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07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xmlns="" val="255498884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39774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49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37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246757229"/>
                  </a:ext>
                </a:extLst>
              </a:tr>
              <a:tr h="28393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39774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171</a:t>
                      </a:r>
                      <a:endParaRPr lang="de-D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0.43</a:t>
                      </a:r>
                      <a:endParaRPr lang="de-D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758489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460082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Microsoft Office PowerPoint</Application>
  <PresentationFormat>Breitbild</PresentationFormat>
  <Paragraphs>5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nekathrin Haberland</dc:creator>
  <cp:lastModifiedBy>Haberland</cp:lastModifiedBy>
  <cp:revision>5</cp:revision>
  <dcterms:created xsi:type="dcterms:W3CDTF">2018-02-01T08:22:36Z</dcterms:created>
  <dcterms:modified xsi:type="dcterms:W3CDTF">2018-02-01T08:39:02Z</dcterms:modified>
</cp:coreProperties>
</file>